
<file path=[Content_Types].xml><?xml version="1.0" encoding="utf-8"?>
<Types xmlns="http://schemas.openxmlformats.org/package/2006/content-types">
  <Default Extension="bin" ContentType="application/vnd.openxmlformats-officedocument.oleObject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emf" ContentType="image/x-emf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vml" ContentType="application/vnd.openxmlformats-officedocument.vmlDrawing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60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9207D-84AD-4742-B937-DA1B7666D3EA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7D5AD-6464-4985-B1FF-FB9EB6BCB3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9016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9207D-84AD-4742-B937-DA1B7666D3EA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7D5AD-6464-4985-B1FF-FB9EB6BCB3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7582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9207D-84AD-4742-B937-DA1B7666D3EA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7D5AD-6464-4985-B1FF-FB9EB6BCB3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43854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9207D-84AD-4742-B937-DA1B7666D3EA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7D5AD-6464-4985-B1FF-FB9EB6BCB3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28852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9207D-84AD-4742-B937-DA1B7666D3EA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7D5AD-6464-4985-B1FF-FB9EB6BCB3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98561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9207D-84AD-4742-B937-DA1B7666D3EA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7D5AD-6464-4985-B1FF-FB9EB6BCB3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7364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9207D-84AD-4742-B937-DA1B7666D3EA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7D5AD-6464-4985-B1FF-FB9EB6BCB3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68253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9207D-84AD-4742-B937-DA1B7666D3EA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7D5AD-6464-4985-B1FF-FB9EB6BCB3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11460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9207D-84AD-4742-B937-DA1B7666D3EA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7D5AD-6464-4985-B1FF-FB9EB6BCB3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88545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9207D-84AD-4742-B937-DA1B7666D3EA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7D5AD-6464-4985-B1FF-FB9EB6BCB3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729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9207D-84AD-4742-B937-DA1B7666D3EA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7D5AD-6464-4985-B1FF-FB9EB6BCB3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5732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19207D-84AD-4742-B937-DA1B7666D3EA}" type="datetimeFigureOut">
              <a:rPr lang="fr-FR" smtClean="0"/>
              <a:t>10/0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B7D5AD-6464-4985-B1FF-FB9EB6BCB3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3379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9736069"/>
              </p:ext>
            </p:extLst>
          </p:nvPr>
        </p:nvGraphicFramePr>
        <p:xfrm>
          <a:off x="1259632" y="432495"/>
          <a:ext cx="5832648" cy="44336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9" name="Prism Project" r:id="rId3" imgW="6876000" imgH="5292000" progId="Prism5.Document">
                  <p:embed/>
                </p:oleObj>
              </mc:Choice>
              <mc:Fallback>
                <p:oleObj name="Prism Project" r:id="rId3" imgW="6876000" imgH="5292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59632" y="432495"/>
                        <a:ext cx="5832648" cy="44336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ZoneTexte 2"/>
          <p:cNvSpPr txBox="1"/>
          <p:nvPr/>
        </p:nvSpPr>
        <p:spPr>
          <a:xfrm>
            <a:off x="1043608" y="5131926"/>
            <a:ext cx="69847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expression to actin of gastrointestinal peptides in 48h-fasted and 2h refed adult rats (n=3-4). **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difference from fasting (Mann Whitney tes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686139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974DBB106E0E840B4BFB421FBB4B03E" ma:contentTypeVersion="7" ma:contentTypeDescription="Create a new document." ma:contentTypeScope="" ma:versionID="5c68492d143f05cff87d91a2ed2cfc3f">
  <xsd:schema xmlns:xsd="http://www.w3.org/2001/XMLSchema" xmlns:p="http://schemas.microsoft.com/office/2006/metadata/properties" xmlns:ns2="493a9880-0e70-44a9-baa7-81bb23140a10" targetNamespace="http://schemas.microsoft.com/office/2006/metadata/properties" ma:root="true" ma:fieldsID="8c178fe84d44c1b67aadd558325d7451" ns2:_="">
    <xsd:import namespace="493a9880-0e70-44a9-baa7-81bb23140a1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493a9880-0e70-44a9-baa7-81bb23140a1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IsDeleted xmlns="493a9880-0e70-44a9-baa7-81bb23140a10">false</IsDeleted>
    <DocumentType xmlns="493a9880-0e70-44a9-baa7-81bb23140a10">Presentation</DocumentType>
    <Checked_x0020_Out_x0020_To xmlns="493a9880-0e70-44a9-baa7-81bb23140a10">
      <UserInfo>
        <DisplayName/>
        <AccountId xsi:nil="true"/>
        <AccountType/>
      </UserInfo>
    </Checked_x0020_Out_x0020_To>
    <FileFormat xmlns="493a9880-0e70-44a9-baa7-81bb23140a10">PPTX</FileFormat>
    <StageName xmlns="493a9880-0e70-44a9-baa7-81bb23140a10" xsi:nil="true"/>
    <TitleName xmlns="493a9880-0e70-44a9-baa7-81bb23140a10">Presentation 1.PPTX</TitleName>
    <DocumentId xmlns="493a9880-0e70-44a9-baa7-81bb23140a10">Presentation 1.PPTX</DocumentId>
  </documentManagement>
</p:properties>
</file>

<file path=customXml/itemProps1.xml><?xml version="1.0" encoding="utf-8"?>
<ds:datastoreItem xmlns:ds="http://schemas.openxmlformats.org/officeDocument/2006/customXml" ds:itemID="{713ED7EC-DD5D-479C-80DD-F300CB404B96}"/>
</file>

<file path=customXml/itemProps2.xml><?xml version="1.0" encoding="utf-8"?>
<ds:datastoreItem xmlns:ds="http://schemas.openxmlformats.org/officeDocument/2006/customXml" ds:itemID="{248CFF58-5BFD-4BA1-8AE2-6D08DB63DAD8}"/>
</file>

<file path=customXml/itemProps3.xml><?xml version="1.0" encoding="utf-8"?>
<ds:datastoreItem xmlns:ds="http://schemas.openxmlformats.org/officeDocument/2006/customXml" ds:itemID="{65453F3C-5BC3-4DAE-A442-B01D3612D1B2}"/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32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Thème Office</vt:lpstr>
      <vt:lpstr>Prism Project</vt:lpstr>
      <vt:lpstr>Présentation PowerPoint</vt:lpstr>
    </vt:vector>
  </TitlesOfParts>
  <Company> 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eDrean G</dc:creator>
  <cp:lastModifiedBy>LeDrean G</cp:lastModifiedBy>
  <cp:revision>7</cp:revision>
  <dcterms:created xsi:type="dcterms:W3CDTF">2016-11-21T17:37:05Z</dcterms:created>
  <dcterms:modified xsi:type="dcterms:W3CDTF">2017-01-10T16:54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974DBB106E0E840B4BFB421FBB4B03E</vt:lpwstr>
  </property>
</Properties>
</file>